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0080625" cy="5670550"/>
  <p:notesSz cx="7559675" cy="10691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7"/>
  </p:normalViewPr>
  <p:slideViewPr>
    <p:cSldViewPr snapToGrid="0" snapToObjects="1">
      <p:cViewPr varScale="1">
        <p:scale>
          <a:sx n="105" d="100"/>
          <a:sy n="105" d="100"/>
        </p:scale>
        <p:origin x="-696" y="-112"/>
      </p:cViewPr>
      <p:guideLst>
        <p:guide orient="horz" pos="1786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04000" y="304416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15268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357120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663804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50400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357120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663804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1640" cy="4388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515268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504000" y="5165280"/>
            <a:ext cx="2348280" cy="39060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US" sz="1400" b="0" strike="noStrike" spc="-1">
                <a:latin typeface="Times New Roman"/>
              </a:rPr>
              <a:t>&lt;date/time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3447360" y="5165280"/>
            <a:ext cx="3195000" cy="39060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ctr"/>
            <a:r>
              <a:rPr lang="en-US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7227360" y="5165280"/>
            <a:ext cx="2348280" cy="39060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fld id="{E59A6FF2-304A-47CD-833B-F534406D547B}" type="slidenum">
              <a:rPr lang="en-US" sz="1400" b="0" strike="noStrike" spc="-1">
                <a:latin typeface="Times New Roman"/>
              </a:rPr>
              <a:t>‹Nr.›</a:t>
            </a:fld>
            <a:endParaRPr lang="en-US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n 40"/>
          <p:cNvPicPr/>
          <p:nvPr/>
        </p:nvPicPr>
        <p:blipFill>
          <a:blip r:embed="rId2"/>
          <a:stretch/>
        </p:blipFill>
        <p:spPr>
          <a:xfrm>
            <a:off x="1593800" y="441396"/>
            <a:ext cx="7093000" cy="3826684"/>
          </a:xfrm>
          <a:prstGeom prst="rect">
            <a:avLst/>
          </a:prstGeom>
          <a:ln>
            <a:noFill/>
          </a:ln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7E6FC018-3CCB-0B4E-9452-3476BF0682AB}"/>
              </a:ext>
            </a:extLst>
          </p:cNvPr>
          <p:cNvSpPr/>
          <p:nvPr/>
        </p:nvSpPr>
        <p:spPr>
          <a:xfrm>
            <a:off x="274320" y="4592320"/>
            <a:ext cx="909354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2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sertion detection bias between CAAS and IRIS varieties. Number of PoopulationTE2 filtered insertions per variety in 1059 coverage-homogenized genomes.</a:t>
            </a:r>
            <a:endParaRPr lang="x-none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Words>26</Words>
  <Application>Microsoft Macintosh PowerPoint</Application>
  <PresentationFormat>Personalizad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/>
  <dc:description/>
  <cp:lastModifiedBy>Josep Casacuberta</cp:lastModifiedBy>
  <cp:revision>6</cp:revision>
  <dcterms:created xsi:type="dcterms:W3CDTF">2020-07-27T12:03:18Z</dcterms:created>
  <dcterms:modified xsi:type="dcterms:W3CDTF">2020-11-09T17:37:37Z</dcterms:modified>
  <dc:language>en-US</dc:language>
</cp:coreProperties>
</file>